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72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l="37574" t="17900" r="32145" b="10836"/>
          <a:stretch>
            <a:fillRect/>
          </a:stretch>
        </p:blipFill>
        <p:spPr bwMode="auto">
          <a:xfrm>
            <a:off x="836712" y="179512"/>
            <a:ext cx="4968552" cy="7308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260648" y="25152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7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20688" y="7538844"/>
            <a:ext cx="55446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7: Gene ontology enrichment analysis of maize genes induced after infection with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strain SG200∆tin4 at 4 dpi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GOEAST software toolki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43]</a:t>
            </a:r>
            <a:r>
              <a:rPr lang="en-US" sz="1200" smtClean="0">
                <a:solidFill>
                  <a:srgbClr val="00B0F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used to identify GO terms for cellular processes (yellow boxes) that are specifically enriched in maiz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in SG200∆tin4. Darker color shades indicate higher significance of enrichme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values are indicated in brackets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-Design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tanaka</cp:lastModifiedBy>
  <cp:revision>2</cp:revision>
  <dcterms:modified xsi:type="dcterms:W3CDTF">2014-05-15T12:15:34Z</dcterms:modified>
</cp:coreProperties>
</file>